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327"/>
  </p:normalViewPr>
  <p:slideViewPr>
    <p:cSldViewPr snapToGrid="0">
      <p:cViewPr varScale="1">
        <p:scale>
          <a:sx n="71" d="100"/>
          <a:sy n="71" d="100"/>
        </p:scale>
        <p:origin x="60" y="9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2F300E-2E82-FC1B-A27B-7EF3EB8E88E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AFA97EF-A304-3756-6079-E173463C112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9037DED-5442-5980-8506-1B6AD44818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DC24BE4-E25F-711C-5DBD-6FAFBCF03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BD1544-A09B-3EB1-D21E-62BF4C1ED04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1202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4D0B8E-1771-59AB-F8FA-7A37BA3EF8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546C535-F806-2163-494B-22C0638AB8B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BF68B47-B942-E081-1400-C476C1A16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4CF5B1-4958-13C2-E0C5-516DA0114E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491647A-5610-00F6-774A-F19AD05C15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2863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F35610A-73B3-ADCB-534A-6EEEA1BF54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99227EE-F4EA-CB92-00AB-99F7B196625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F2B368-72E7-321C-E212-1DE40062B3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EF9134-795B-1BCE-9F0D-B2AC19EBFE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A994E8-6713-3580-FE04-E745E1E471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4752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A6FF34-35A6-027D-B36C-6AE8E6BA2D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7ECFE70-354C-2215-2B3D-2515F59C79A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CF89D4-C3F7-5DCC-4B44-B12CCDC3FF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B0763B-BF61-E6D1-BB8D-CA491F4042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A01D0C-44BF-C9FE-886A-90B9825DAB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2744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35EC4D-B5A0-C19A-DF13-04130FB723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275E3B9-F3EB-2A6F-D47E-0AF4536BC4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707187B-0FA0-F1E9-33B9-34143E5BD5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EFD6F2F-71F8-563B-AF56-DA18C1B5B1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85BD101-274E-AC41-C3F9-033DF7AABC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389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B3653B-2CDF-2626-E3BF-EBB9562225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209F88D-DB4D-9075-ADFC-3B2D51738B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9B3ADAE-0187-8268-B50D-957440ECD27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8B005A2-CBE5-97D5-A974-482BC3462B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C515AC-6919-0016-0B0C-F7D7EAA844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48D488-BD01-895E-9B06-47184018D9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0399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DA92C9-6C24-4479-308F-656A550DE6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35A5786-2B02-FFBA-7687-05D98459D3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32A8A4-1BBE-145F-0628-D00A8D4F99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904A286-C586-82F6-C240-D0CE3ADA23B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F7F62F5-A0B0-A09C-0DAE-26D65048FE1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8B053C-2B6E-BB70-F993-A0AE826D50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69B7CAB-0876-603D-1894-798E0B0D02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7A10859-920F-442A-DF0D-2C18DB8E7F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8227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A885215-FA4A-304D-754C-ADA312AC8C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3799AFF-7369-3444-8C0E-3266646ADB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43E7A7-0A8E-7BA6-D76E-0607E5E17A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D40863BC-3B60-207D-87D1-28982B7007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87629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04BC8DE-B3B5-F979-84CE-2067B97AE2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F9AA8EC-DA0E-1662-DE37-2B9A94B306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1415A8A-9D45-3212-2F00-E6378B2AB1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20507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7861A3-678B-0D12-01E1-B507ED6E51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D2A714-2A81-443F-7467-5A69123E98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6BF9BBE-F26D-6457-21F7-EFBD15C0AF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E73752-F393-88E6-F1C8-8B63135B9D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7AB2B6D-0359-C47E-F8E9-B2BE473D4B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EBF6775-617F-C623-0E46-D8EEE1828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2591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F86506-6C96-D72F-7AAD-FFA59FDD314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97CA59B-FA90-63A6-B71C-3A3115C0045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0023F73-7EE7-7ED9-2A53-A76604BD62C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658820-7A60-3AB5-190C-859067DF8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282852-BB69-B702-5A36-F9FEE611D8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71A624A-203D-AB8C-F90D-C2DCA913CFC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290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A3610FD-6477-51BA-03E2-DE5321A546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43EA68D-936A-B6D1-B676-96475C65BC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3B4C62B-899C-9E91-6DF3-915F39D4D74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E13DAB0-D048-1C4E-895C-CB712B8F57E4}" type="datetimeFigureOut">
              <a:rPr lang="en-US" smtClean="0"/>
              <a:t>5/26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A94F254-B411-25C6-E723-F4D568752D5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7AA320-DC6E-4785-72F6-177CE90EAD6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B053CD-080C-3E42-A2EC-D195B73E9AF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514435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screenshot of a computer&#10;&#10;Description automatically generated with medium confidence">
            <a:extLst>
              <a:ext uri="{FF2B5EF4-FFF2-40B4-BE49-F238E27FC236}">
                <a16:creationId xmlns:a16="http://schemas.microsoft.com/office/drawing/2014/main" id="{231CB6B9-411E-DC3C-3AA1-9E88F1255FB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603" y="0"/>
            <a:ext cx="11634793" cy="68580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4800B16-F9FB-16CB-7CFA-DF4DAF985F44}"/>
              </a:ext>
            </a:extLst>
          </p:cNvPr>
          <p:cNvSpPr txBox="1"/>
          <p:nvPr/>
        </p:nvSpPr>
        <p:spPr>
          <a:xfrm>
            <a:off x="3595955" y="5188449"/>
            <a:ext cx="2116476" cy="923330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/>
              <a:t>Short-clipped reads with CMV promoter sequence</a:t>
            </a:r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876B451A-911D-6090-310C-EE1771441075}"/>
              </a:ext>
            </a:extLst>
          </p:cNvPr>
          <p:cNvCxnSpPr>
            <a:stCxn id="6" idx="3"/>
          </p:cNvCxnSpPr>
          <p:nvPr/>
        </p:nvCxnSpPr>
        <p:spPr>
          <a:xfrm>
            <a:off x="5712431" y="5650114"/>
            <a:ext cx="616450" cy="1094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588C3A55-7214-F1A0-A134-3828BFC4CE00}"/>
              </a:ext>
            </a:extLst>
          </p:cNvPr>
          <p:cNvSpPr txBox="1"/>
          <p:nvPr/>
        </p:nvSpPr>
        <p:spPr>
          <a:xfrm>
            <a:off x="8270695" y="4294597"/>
            <a:ext cx="2116476" cy="646331"/>
          </a:xfrm>
          <a:prstGeom prst="rect">
            <a:avLst/>
          </a:prstGeom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rtlCol="0">
            <a:spAutoFit/>
          </a:bodyPr>
          <a:lstStyle/>
          <a:p>
            <a:r>
              <a:rPr lang="en-US" dirty="0"/>
              <a:t>WES reads clipped at edges of exons</a:t>
            </a:r>
          </a:p>
        </p:txBody>
      </p:sp>
      <p:cxnSp>
        <p:nvCxnSpPr>
          <p:cNvPr id="10" name="Straight Arrow Connector 9">
            <a:extLst>
              <a:ext uri="{FF2B5EF4-FFF2-40B4-BE49-F238E27FC236}">
                <a16:creationId xmlns:a16="http://schemas.microsoft.com/office/drawing/2014/main" id="{0FCF9901-45DB-5A7D-4B62-79F5D0222E2F}"/>
              </a:ext>
            </a:extLst>
          </p:cNvPr>
          <p:cNvCxnSpPr>
            <a:cxnSpLocks/>
            <a:stCxn id="9" idx="3"/>
          </p:cNvCxnSpPr>
          <p:nvPr/>
        </p:nvCxnSpPr>
        <p:spPr>
          <a:xfrm>
            <a:off x="10387171" y="4617763"/>
            <a:ext cx="328775" cy="77527"/>
          </a:xfrm>
          <a:prstGeom prst="straightConnector1">
            <a:avLst/>
          </a:prstGeom>
          <a:ln>
            <a:tailEnd type="triangle"/>
          </a:ln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672324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A0625B46-7110-4DB0-96AA-9188CF5FF140}"/>
              </a:ext>
            </a:extLst>
          </p:cNvPr>
          <p:cNvSpPr/>
          <p:nvPr/>
        </p:nvSpPr>
        <p:spPr>
          <a:xfrm>
            <a:off x="322729" y="98537"/>
            <a:ext cx="11631706" cy="33369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3.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Detection of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talimogene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dirty="0" err="1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laherparepvec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T-VEC) vector reads in case #2. This screenshot from the integrated genomics viewer shows reads aligning to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F2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GM-CSF) from the peripheral blood, baseline, and end-of-treatment (EOT) whole exome sequencing (WES) data from the surgical specimen of case #2. The short-clipped ends of the reads at the 5’ end of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F2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ontained the T-VEC cytomegalovirus (CMV) promoter sequence, and reads spanned the exon-exon junctions of the </a:t>
            </a:r>
            <a:r>
              <a:rPr lang="en-US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SF2</a:t>
            </a:r>
            <a:r>
              <a:rPr lang="en-US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ranscript. This pattern was not observed in the surgical (EOT) specimens from the other patients or in baseline samples.</a:t>
            </a:r>
            <a:endParaRPr lang="en-US" sz="20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415245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129</Words>
  <Application>Microsoft Office PowerPoint</Application>
  <PresentationFormat>Widescreen</PresentationFormat>
  <Paragraphs>3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mpbell, Katie M.</dc:creator>
  <cp:lastModifiedBy>Ribas, Antoni</cp:lastModifiedBy>
  <cp:revision>2</cp:revision>
  <dcterms:created xsi:type="dcterms:W3CDTF">2023-05-26T21:04:40Z</dcterms:created>
  <dcterms:modified xsi:type="dcterms:W3CDTF">2023-05-26T23:51:53Z</dcterms:modified>
</cp:coreProperties>
</file>